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1C2016-097C-40C5-B352-8850E93E07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44EE14-A234-4A4D-9F9B-8D624CF65E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AF037-2039-4663-8173-4EA1AA5DD3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B9EBC6-3AEB-42F7-A5D2-2C8EDE1119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3215E-0D31-4FDF-BF2A-EC9FB4AB4E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AE7DC-783C-4B51-8472-123274C560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D97E8A-AEE0-4F6D-81BE-EC8584A7D5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16ACA3-9BBA-4E9A-8000-86792BFF73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FDBC86-338C-441C-A187-36637387D5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766F89-5450-45CF-BB1A-D672E5D550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4F6FAA-25BB-42F5-970C-B112F8FA6E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4CC292-7930-466F-836A-B2AFF48EB0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FA719D-EA4A-4F8F-8E68-EC734F042C3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"/>
          <p:cNvGrpSpPr/>
          <p:nvPr/>
        </p:nvGrpSpPr>
        <p:grpSpPr>
          <a:xfrm>
            <a:off x="178200" y="254160"/>
            <a:ext cx="3478680" cy="4546080"/>
            <a:chOff x="178200" y="254160"/>
            <a:chExt cx="3478680" cy="4546080"/>
          </a:xfrm>
        </p:grpSpPr>
        <p:pic>
          <p:nvPicPr>
            <p:cNvPr id="42" name="Picture 3" descr="C:\Documents and Settings\Sacchettini Lab\My Documents\Satheesh\TTR_elisabetta\image_fine1.tif"/>
            <p:cNvPicPr/>
            <p:nvPr/>
          </p:nvPicPr>
          <p:blipFill>
            <a:blip r:embed="rId1"/>
            <a:srcRect l="23117" t="0" r="27578" b="322"/>
            <a:stretch/>
          </p:blipFill>
          <p:spPr>
            <a:xfrm>
              <a:off x="358200" y="254160"/>
              <a:ext cx="3298680" cy="4020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6"/>
            <p:cNvSpPr/>
            <p:nvPr/>
          </p:nvSpPr>
          <p:spPr>
            <a:xfrm>
              <a:off x="1039680" y="2803680"/>
              <a:ext cx="557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r11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7"/>
            <p:cNvSpPr/>
            <p:nvPr/>
          </p:nvSpPr>
          <p:spPr>
            <a:xfrm>
              <a:off x="2410200" y="2793600"/>
              <a:ext cx="58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r117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11"/>
            <p:cNvSpPr/>
            <p:nvPr/>
          </p:nvSpPr>
          <p:spPr>
            <a:xfrm>
              <a:off x="758160" y="2052360"/>
              <a:ext cx="557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r1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12"/>
            <p:cNvSpPr/>
            <p:nvPr/>
          </p:nvSpPr>
          <p:spPr>
            <a:xfrm>
              <a:off x="383040" y="1442880"/>
              <a:ext cx="551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la10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13"/>
            <p:cNvSpPr/>
            <p:nvPr/>
          </p:nvSpPr>
          <p:spPr>
            <a:xfrm>
              <a:off x="977400" y="3094200"/>
              <a:ext cx="58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r117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14"/>
            <p:cNvSpPr/>
            <p:nvPr/>
          </p:nvSpPr>
          <p:spPr>
            <a:xfrm>
              <a:off x="178200" y="376920"/>
              <a:ext cx="557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r10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5"/>
            <p:cNvSpPr/>
            <p:nvPr/>
          </p:nvSpPr>
          <p:spPr>
            <a:xfrm>
              <a:off x="1425600" y="376920"/>
              <a:ext cx="50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Lys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16"/>
            <p:cNvSpPr/>
            <p:nvPr/>
          </p:nvSpPr>
          <p:spPr>
            <a:xfrm>
              <a:off x="2526120" y="3094200"/>
              <a:ext cx="58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r117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7"/>
            <p:cNvSpPr/>
            <p:nvPr/>
          </p:nvSpPr>
          <p:spPr>
            <a:xfrm>
              <a:off x="2892960" y="1442880"/>
              <a:ext cx="583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la108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8"/>
            <p:cNvSpPr/>
            <p:nvPr/>
          </p:nvSpPr>
          <p:spPr>
            <a:xfrm>
              <a:off x="2318040" y="325440"/>
              <a:ext cx="538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Lys15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9"/>
            <p:cNvSpPr/>
            <p:nvPr/>
          </p:nvSpPr>
          <p:spPr>
            <a:xfrm>
              <a:off x="2652840" y="2103120"/>
              <a:ext cx="58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r119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20"/>
            <p:cNvSpPr/>
            <p:nvPr/>
          </p:nvSpPr>
          <p:spPr>
            <a:xfrm>
              <a:off x="2241720" y="1384200"/>
              <a:ext cx="835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u17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21"/>
            <p:cNvSpPr/>
            <p:nvPr/>
          </p:nvSpPr>
          <p:spPr>
            <a:xfrm>
              <a:off x="1385280" y="1357200"/>
              <a:ext cx="51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u1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22"/>
            <p:cNvSpPr/>
            <p:nvPr/>
          </p:nvSpPr>
          <p:spPr>
            <a:xfrm>
              <a:off x="873720" y="1036440"/>
              <a:ext cx="545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Val12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23"/>
            <p:cNvSpPr/>
            <p:nvPr/>
          </p:nvSpPr>
          <p:spPr>
            <a:xfrm>
              <a:off x="2669400" y="1159200"/>
              <a:ext cx="57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Val121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5"/>
            <p:cNvSpPr/>
            <p:nvPr/>
          </p:nvSpPr>
          <p:spPr>
            <a:xfrm>
              <a:off x="1000440" y="3132720"/>
              <a:ext cx="2270160" cy="1667520"/>
            </a:xfrm>
            <a:prstGeom prst="rect">
              <a:avLst/>
            </a:prstGeom>
            <a:noFill/>
            <a:ln cap="sq" w="1584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36"/>
            <p:cNvSpPr/>
            <p:nvPr/>
          </p:nvSpPr>
          <p:spPr>
            <a:xfrm>
              <a:off x="1596600" y="4275000"/>
              <a:ext cx="792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 subuni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0" name="" descr=""/>
          <p:cNvPicPr/>
          <p:nvPr/>
        </p:nvPicPr>
        <p:blipFill>
          <a:blip r:embed="rId2"/>
          <a:srcRect l="21104" t="2623" r="21344" b="0"/>
          <a:stretch/>
        </p:blipFill>
        <p:spPr>
          <a:xfrm>
            <a:off x="4572000" y="380880"/>
            <a:ext cx="3200400" cy="396252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6834240" y="1427040"/>
            <a:ext cx="69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rg1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485680" y="50652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yr3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104800" y="1851120"/>
            <a:ext cx="66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al3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019920" y="2849400"/>
            <a:ext cx="69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et5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745160" y="330660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rp38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822240" y="201780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109880" y="1952640"/>
            <a:ext cx="65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9999"/>
                </a:solidFill>
                <a:latin typeface="Arial"/>
              </a:rPr>
              <a:t>HBP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992520" y="1371600"/>
            <a:ext cx="65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9999"/>
                </a:solidFill>
                <a:latin typeface="Arial"/>
              </a:rPr>
              <a:t>HBP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068480" y="914400"/>
            <a:ext cx="65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9999"/>
                </a:solidFill>
                <a:latin typeface="Arial"/>
              </a:rPr>
              <a:t>HBP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975960" y="544680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12T21:03:11Z</dcterms:created>
  <dc:creator>James C. Sacchettini</dc:creator>
  <dc:description/>
  <dc:language>en-US</dc:language>
  <cp:lastModifiedBy>James C. Sacchettini</cp:lastModifiedBy>
  <dcterms:modified xsi:type="dcterms:W3CDTF">2009-06-12T21:03:16Z</dcterms:modified>
  <cp:revision>1</cp:revision>
  <dc:subject/>
  <dc:title>Slide 1</dc:title>
</cp:coreProperties>
</file>